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B30C9F-FB8D-44B7-A8DD-D48027518A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1B9B4C-3FD3-4CB2-A2F2-9D24DDDE3B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24D785-A616-4860-978B-D3F94BD57E6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679ADA-EDE2-41D5-A79D-3F85BDBC616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04B08E-4D02-4385-9FFB-4A10E85510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079FF-3C29-443C-A77D-04166E3180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0C3E73-B0A4-4C90-BF0B-4F772905AA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ECCAE0-9656-4B8F-A2F9-CDE953E03D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3F04F7-F759-47B4-BBA9-AFAEB2E71E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FDB4D3-C1C4-478F-B5A5-FE10611A67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FED866-BB79-49FE-B4AF-ABB06B2AA2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FCA3BD-E125-460D-8869-A70B9D2F5E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969017-3950-431F-BF5C-26CB173F0D3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09480" y="2514600"/>
            <a:ext cx="2667240" cy="264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dditional Data File 5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Representative flow cytometric quantitation of vimentin expression by CD24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</a:rPr>
              <a:t>po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and CD24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</a:rPr>
              <a:t>ne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Ca1a cells. CD24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</a:rPr>
              <a:t>ne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and CD24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</a:rPr>
              <a:t>po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populations were gated and evaluated for their expression of vimentin.  CD24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</a:rPr>
              <a:t>ne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cells are represented with the red plot and CD24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</a:rPr>
              <a:t>po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cells are represented with the blue plot. Median fluorescence intensity in the PE channel for CD24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</a:rPr>
              <a:t>ne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cells was 1494.  Median fluorescence intensity in the PE channel for CD24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</a:rPr>
              <a:t>po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cells was 7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838080" y="609480"/>
            <a:ext cx="1957680" cy="1884960"/>
            <a:chOff x="838080" y="609480"/>
            <a:chExt cx="1957680" cy="1884960"/>
          </a:xfrm>
        </p:grpSpPr>
        <p:grpSp>
          <p:nvGrpSpPr>
            <p:cNvPr id="43" name=""/>
            <p:cNvGrpSpPr/>
            <p:nvPr/>
          </p:nvGrpSpPr>
          <p:grpSpPr>
            <a:xfrm>
              <a:off x="838080" y="609480"/>
              <a:ext cx="1957680" cy="1884960"/>
              <a:chOff x="838080" y="609480"/>
              <a:chExt cx="1957680" cy="1884960"/>
            </a:xfrm>
          </p:grpSpPr>
          <p:sp>
            <p:nvSpPr>
              <p:cNvPr id="44" name=""/>
              <p:cNvSpPr/>
              <p:nvPr/>
            </p:nvSpPr>
            <p:spPr>
              <a:xfrm>
                <a:off x="1130040" y="609480"/>
                <a:ext cx="1595520" cy="159552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5" name=""/>
              <p:cNvGrpSpPr/>
              <p:nvPr/>
            </p:nvGrpSpPr>
            <p:grpSpPr>
              <a:xfrm>
                <a:off x="1064880" y="2198520"/>
                <a:ext cx="1730880" cy="295920"/>
                <a:chOff x="1064880" y="2198520"/>
                <a:chExt cx="1730880" cy="295920"/>
              </a:xfrm>
            </p:grpSpPr>
            <p:sp>
              <p:nvSpPr>
                <p:cNvPr id="46" name=""/>
                <p:cNvSpPr/>
                <p:nvPr/>
              </p:nvSpPr>
              <p:spPr>
                <a:xfrm>
                  <a:off x="1130040" y="2198520"/>
                  <a:ext cx="1589040" cy="18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7" name=""/>
                <p:cNvGrpSpPr/>
                <p:nvPr/>
              </p:nvGrpSpPr>
              <p:grpSpPr>
                <a:xfrm>
                  <a:off x="1130040" y="2205000"/>
                  <a:ext cx="1590840" cy="36720"/>
                  <a:chOff x="1130040" y="2205000"/>
                  <a:chExt cx="1590840" cy="36720"/>
                </a:xfrm>
              </p:grpSpPr>
              <p:sp>
                <p:nvSpPr>
                  <p:cNvPr id="48" name=""/>
                  <p:cNvSpPr/>
                  <p:nvPr/>
                </p:nvSpPr>
                <p:spPr>
                  <a:xfrm>
                    <a:off x="1130040" y="2205000"/>
                    <a:ext cx="1800" cy="36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0080" bIns="-10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" name=""/>
                  <p:cNvSpPr/>
                  <p:nvPr/>
                </p:nvSpPr>
                <p:spPr>
                  <a:xfrm>
                    <a:off x="124776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" name=""/>
                  <p:cNvSpPr/>
                  <p:nvPr/>
                </p:nvSpPr>
                <p:spPr>
                  <a:xfrm>
                    <a:off x="131436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" name=""/>
                  <p:cNvSpPr/>
                  <p:nvPr/>
                </p:nvSpPr>
                <p:spPr>
                  <a:xfrm>
                    <a:off x="136512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" name=""/>
                  <p:cNvSpPr/>
                  <p:nvPr/>
                </p:nvSpPr>
                <p:spPr>
                  <a:xfrm>
                    <a:off x="1407960" y="2205000"/>
                    <a:ext cx="1440" cy="255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1240" bIns="-212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" name=""/>
                  <p:cNvSpPr/>
                  <p:nvPr/>
                </p:nvSpPr>
                <p:spPr>
                  <a:xfrm>
                    <a:off x="143964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" name=""/>
                  <p:cNvSpPr/>
                  <p:nvPr/>
                </p:nvSpPr>
                <p:spPr>
                  <a:xfrm>
                    <a:off x="1463400" y="2205000"/>
                    <a:ext cx="180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" name=""/>
                  <p:cNvSpPr/>
                  <p:nvPr/>
                </p:nvSpPr>
                <p:spPr>
                  <a:xfrm>
                    <a:off x="1487160" y="2205000"/>
                    <a:ext cx="180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" name=""/>
                  <p:cNvSpPr/>
                  <p:nvPr/>
                </p:nvSpPr>
                <p:spPr>
                  <a:xfrm>
                    <a:off x="1506240" y="2205000"/>
                    <a:ext cx="180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" name=""/>
                  <p:cNvSpPr/>
                  <p:nvPr/>
                </p:nvSpPr>
                <p:spPr>
                  <a:xfrm>
                    <a:off x="1525320" y="2205000"/>
                    <a:ext cx="1800" cy="36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0080" bIns="-10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" name=""/>
                  <p:cNvSpPr/>
                  <p:nvPr/>
                </p:nvSpPr>
                <p:spPr>
                  <a:xfrm>
                    <a:off x="164772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" name=""/>
                  <p:cNvSpPr/>
                  <p:nvPr/>
                </p:nvSpPr>
                <p:spPr>
                  <a:xfrm>
                    <a:off x="1715760" y="2205000"/>
                    <a:ext cx="180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" name=""/>
                  <p:cNvSpPr/>
                  <p:nvPr/>
                </p:nvSpPr>
                <p:spPr>
                  <a:xfrm>
                    <a:off x="176508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" name=""/>
                  <p:cNvSpPr/>
                  <p:nvPr/>
                </p:nvSpPr>
                <p:spPr>
                  <a:xfrm>
                    <a:off x="1801440" y="2205000"/>
                    <a:ext cx="1800" cy="255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1240" bIns="-212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" name=""/>
                  <p:cNvSpPr/>
                  <p:nvPr/>
                </p:nvSpPr>
                <p:spPr>
                  <a:xfrm>
                    <a:off x="183816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" name=""/>
                  <p:cNvSpPr/>
                  <p:nvPr/>
                </p:nvSpPr>
                <p:spPr>
                  <a:xfrm>
                    <a:off x="1863360" y="2205000"/>
                    <a:ext cx="180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" name=""/>
                  <p:cNvSpPr/>
                  <p:nvPr/>
                </p:nvSpPr>
                <p:spPr>
                  <a:xfrm>
                    <a:off x="188892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" name=""/>
                  <p:cNvSpPr/>
                  <p:nvPr/>
                </p:nvSpPr>
                <p:spPr>
                  <a:xfrm>
                    <a:off x="190656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" name=""/>
                  <p:cNvSpPr/>
                  <p:nvPr/>
                </p:nvSpPr>
                <p:spPr>
                  <a:xfrm>
                    <a:off x="1925280" y="2205000"/>
                    <a:ext cx="1800" cy="36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0080" bIns="-10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" name=""/>
                  <p:cNvSpPr/>
                  <p:nvPr/>
                </p:nvSpPr>
                <p:spPr>
                  <a:xfrm>
                    <a:off x="204300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8" name=""/>
                  <p:cNvSpPr/>
                  <p:nvPr/>
                </p:nvSpPr>
                <p:spPr>
                  <a:xfrm>
                    <a:off x="211608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" name=""/>
                  <p:cNvSpPr/>
                  <p:nvPr/>
                </p:nvSpPr>
                <p:spPr>
                  <a:xfrm>
                    <a:off x="2165040" y="2205000"/>
                    <a:ext cx="180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" name=""/>
                  <p:cNvSpPr/>
                  <p:nvPr/>
                </p:nvSpPr>
                <p:spPr>
                  <a:xfrm>
                    <a:off x="2201760" y="2205000"/>
                    <a:ext cx="1440" cy="255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1240" bIns="-212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" name=""/>
                  <p:cNvSpPr/>
                  <p:nvPr/>
                </p:nvSpPr>
                <p:spPr>
                  <a:xfrm>
                    <a:off x="223344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" name=""/>
                  <p:cNvSpPr/>
                  <p:nvPr/>
                </p:nvSpPr>
                <p:spPr>
                  <a:xfrm>
                    <a:off x="226368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" name=""/>
                  <p:cNvSpPr/>
                  <p:nvPr/>
                </p:nvSpPr>
                <p:spPr>
                  <a:xfrm>
                    <a:off x="228276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" name=""/>
                  <p:cNvSpPr/>
                  <p:nvPr/>
                </p:nvSpPr>
                <p:spPr>
                  <a:xfrm>
                    <a:off x="230652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" name=""/>
                  <p:cNvSpPr/>
                  <p:nvPr/>
                </p:nvSpPr>
                <p:spPr>
                  <a:xfrm>
                    <a:off x="2325600" y="2205000"/>
                    <a:ext cx="1440" cy="36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0080" bIns="-10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" name=""/>
                  <p:cNvSpPr/>
                  <p:nvPr/>
                </p:nvSpPr>
                <p:spPr>
                  <a:xfrm>
                    <a:off x="244296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" name=""/>
                  <p:cNvSpPr/>
                  <p:nvPr/>
                </p:nvSpPr>
                <p:spPr>
                  <a:xfrm>
                    <a:off x="2517480" y="2205000"/>
                    <a:ext cx="180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" name=""/>
                  <p:cNvSpPr/>
                  <p:nvPr/>
                </p:nvSpPr>
                <p:spPr>
                  <a:xfrm>
                    <a:off x="256536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" name=""/>
                  <p:cNvSpPr/>
                  <p:nvPr/>
                </p:nvSpPr>
                <p:spPr>
                  <a:xfrm>
                    <a:off x="2603160" y="2205000"/>
                    <a:ext cx="1800" cy="255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1240" bIns="-212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0" name=""/>
                  <p:cNvSpPr/>
                  <p:nvPr/>
                </p:nvSpPr>
                <p:spPr>
                  <a:xfrm>
                    <a:off x="2633400" y="2205000"/>
                    <a:ext cx="180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" name=""/>
                  <p:cNvSpPr/>
                  <p:nvPr/>
                </p:nvSpPr>
                <p:spPr>
                  <a:xfrm>
                    <a:off x="265896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" name=""/>
                  <p:cNvSpPr/>
                  <p:nvPr/>
                </p:nvSpPr>
                <p:spPr>
                  <a:xfrm>
                    <a:off x="268272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" name=""/>
                  <p:cNvSpPr/>
                  <p:nvPr/>
                </p:nvSpPr>
                <p:spPr>
                  <a:xfrm>
                    <a:off x="2701800" y="2205000"/>
                    <a:ext cx="1440" cy="11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4" name=""/>
                  <p:cNvSpPr/>
                  <p:nvPr/>
                </p:nvSpPr>
                <p:spPr>
                  <a:xfrm>
                    <a:off x="2719080" y="2205000"/>
                    <a:ext cx="1800" cy="36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0080" bIns="-10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85" name=""/>
                <p:cNvGrpSpPr/>
                <p:nvPr/>
              </p:nvGrpSpPr>
              <p:grpSpPr>
                <a:xfrm>
                  <a:off x="1064880" y="2262240"/>
                  <a:ext cx="1730880" cy="138600"/>
                  <a:chOff x="1064880" y="2262240"/>
                  <a:chExt cx="1730880" cy="138600"/>
                </a:xfrm>
              </p:grpSpPr>
              <p:sp>
                <p:nvSpPr>
                  <p:cNvPr id="86" name=""/>
                  <p:cNvSpPr/>
                  <p:nvPr/>
                </p:nvSpPr>
                <p:spPr>
                  <a:xfrm>
                    <a:off x="1064880" y="2293920"/>
                    <a:ext cx="9828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7" name=""/>
                  <p:cNvSpPr/>
                  <p:nvPr/>
                </p:nvSpPr>
                <p:spPr>
                  <a:xfrm>
                    <a:off x="1163160" y="2262240"/>
                    <a:ext cx="4356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6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8" name=""/>
                  <p:cNvSpPr/>
                  <p:nvPr/>
                </p:nvSpPr>
                <p:spPr>
                  <a:xfrm>
                    <a:off x="1458720" y="2293920"/>
                    <a:ext cx="9828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9" name=""/>
                  <p:cNvSpPr/>
                  <p:nvPr/>
                </p:nvSpPr>
                <p:spPr>
                  <a:xfrm>
                    <a:off x="1556640" y="2262240"/>
                    <a:ext cx="4356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6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" name=""/>
                  <p:cNvSpPr/>
                  <p:nvPr/>
                </p:nvSpPr>
                <p:spPr>
                  <a:xfrm>
                    <a:off x="1860480" y="2293920"/>
                    <a:ext cx="9828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" name=""/>
                  <p:cNvSpPr/>
                  <p:nvPr/>
                </p:nvSpPr>
                <p:spPr>
                  <a:xfrm>
                    <a:off x="1958400" y="2262240"/>
                    <a:ext cx="4356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600" spc="-1" strike="noStrike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" name=""/>
                  <p:cNvSpPr/>
                  <p:nvPr/>
                </p:nvSpPr>
                <p:spPr>
                  <a:xfrm>
                    <a:off x="2260440" y="2293920"/>
                    <a:ext cx="9828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" name=""/>
                  <p:cNvSpPr/>
                  <p:nvPr/>
                </p:nvSpPr>
                <p:spPr>
                  <a:xfrm>
                    <a:off x="2358360" y="2262240"/>
                    <a:ext cx="4356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600" spc="-1" strike="noStrike">
                        <a:solidFill>
                          <a:srgbClr val="000000"/>
                        </a:solidFill>
                        <a:latin typeface="Arial"/>
                      </a:rPr>
                      <a:t>3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" name=""/>
                  <p:cNvSpPr/>
                  <p:nvPr/>
                </p:nvSpPr>
                <p:spPr>
                  <a:xfrm>
                    <a:off x="2654280" y="2293920"/>
                    <a:ext cx="9828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" name=""/>
                  <p:cNvSpPr/>
                  <p:nvPr/>
                </p:nvSpPr>
                <p:spPr>
                  <a:xfrm>
                    <a:off x="2752200" y="2262240"/>
                    <a:ext cx="4356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600" spc="-1" strike="noStrike">
                        <a:solidFill>
                          <a:srgbClr val="000000"/>
                        </a:solidFill>
                        <a:latin typeface="Arial"/>
                      </a:rPr>
                      <a:t>4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96" name=""/>
                <p:cNvSpPr/>
                <p:nvPr/>
              </p:nvSpPr>
              <p:spPr>
                <a:xfrm>
                  <a:off x="1756800" y="2387520"/>
                  <a:ext cx="4914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Vimentin-PE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7" name=""/>
              <p:cNvGrpSpPr/>
              <p:nvPr/>
            </p:nvGrpSpPr>
            <p:grpSpPr>
              <a:xfrm>
                <a:off x="838080" y="609480"/>
                <a:ext cx="293760" cy="1654920"/>
                <a:chOff x="838080" y="609480"/>
                <a:chExt cx="293760" cy="1654920"/>
              </a:xfrm>
            </p:grpSpPr>
            <p:sp>
              <p:nvSpPr>
                <p:cNvPr id="98" name=""/>
                <p:cNvSpPr/>
                <p:nvPr/>
              </p:nvSpPr>
              <p:spPr>
                <a:xfrm flipV="1">
                  <a:off x="1130040" y="609480"/>
                  <a:ext cx="1800" cy="15890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99" name=""/>
                <p:cNvGrpSpPr/>
                <p:nvPr/>
              </p:nvGrpSpPr>
              <p:grpSpPr>
                <a:xfrm>
                  <a:off x="924120" y="644400"/>
                  <a:ext cx="147240" cy="1620000"/>
                  <a:chOff x="924120" y="644400"/>
                  <a:chExt cx="147240" cy="1620000"/>
                </a:xfrm>
              </p:grpSpPr>
              <p:sp>
                <p:nvSpPr>
                  <p:cNvPr id="100" name=""/>
                  <p:cNvSpPr/>
                  <p:nvPr/>
                </p:nvSpPr>
                <p:spPr>
                  <a:xfrm>
                    <a:off x="1022040" y="21574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" name=""/>
                  <p:cNvSpPr/>
                  <p:nvPr/>
                </p:nvSpPr>
                <p:spPr>
                  <a:xfrm>
                    <a:off x="973080" y="1855800"/>
                    <a:ext cx="9828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2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" name=""/>
                  <p:cNvSpPr/>
                  <p:nvPr/>
                </p:nvSpPr>
                <p:spPr>
                  <a:xfrm>
                    <a:off x="973080" y="1554120"/>
                    <a:ext cx="9828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4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3" name=""/>
                  <p:cNvSpPr/>
                  <p:nvPr/>
                </p:nvSpPr>
                <p:spPr>
                  <a:xfrm>
                    <a:off x="973080" y="1247760"/>
                    <a:ext cx="9828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6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4" name=""/>
                  <p:cNvSpPr/>
                  <p:nvPr/>
                </p:nvSpPr>
                <p:spPr>
                  <a:xfrm>
                    <a:off x="973080" y="946080"/>
                    <a:ext cx="9828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8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5" name=""/>
                  <p:cNvSpPr/>
                  <p:nvPr/>
                </p:nvSpPr>
                <p:spPr>
                  <a:xfrm>
                    <a:off x="924120" y="644400"/>
                    <a:ext cx="14688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10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06" name=""/>
                <p:cNvGrpSpPr/>
                <p:nvPr/>
              </p:nvGrpSpPr>
              <p:grpSpPr>
                <a:xfrm>
                  <a:off x="1093320" y="684360"/>
                  <a:ext cx="36360" cy="1515960"/>
                  <a:chOff x="1093320" y="684360"/>
                  <a:chExt cx="36360" cy="1515960"/>
                </a:xfrm>
              </p:grpSpPr>
              <p:sp>
                <p:nvSpPr>
                  <p:cNvPr id="107" name=""/>
                  <p:cNvSpPr/>
                  <p:nvPr/>
                </p:nvSpPr>
                <p:spPr>
                  <a:xfrm flipH="1">
                    <a:off x="1093320" y="2198520"/>
                    <a:ext cx="3636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" name=""/>
                  <p:cNvSpPr/>
                  <p:nvPr/>
                </p:nvSpPr>
                <p:spPr>
                  <a:xfrm flipH="1">
                    <a:off x="1118520" y="2125800"/>
                    <a:ext cx="1116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" name=""/>
                  <p:cNvSpPr/>
                  <p:nvPr/>
                </p:nvSpPr>
                <p:spPr>
                  <a:xfrm flipH="1">
                    <a:off x="1118520" y="2050920"/>
                    <a:ext cx="1116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" name=""/>
                  <p:cNvSpPr/>
                  <p:nvPr/>
                </p:nvSpPr>
                <p:spPr>
                  <a:xfrm flipH="1">
                    <a:off x="1118520" y="1971720"/>
                    <a:ext cx="1116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" name=""/>
                  <p:cNvSpPr/>
                  <p:nvPr/>
                </p:nvSpPr>
                <p:spPr>
                  <a:xfrm flipH="1">
                    <a:off x="1093320" y="1897200"/>
                    <a:ext cx="3636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" name=""/>
                  <p:cNvSpPr/>
                  <p:nvPr/>
                </p:nvSpPr>
                <p:spPr>
                  <a:xfrm flipH="1">
                    <a:off x="1118520" y="1824120"/>
                    <a:ext cx="1116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3" name=""/>
                  <p:cNvSpPr/>
                  <p:nvPr/>
                </p:nvSpPr>
                <p:spPr>
                  <a:xfrm flipH="1">
                    <a:off x="1118520" y="1743120"/>
                    <a:ext cx="1116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4" name=""/>
                  <p:cNvSpPr/>
                  <p:nvPr/>
                </p:nvSpPr>
                <p:spPr>
                  <a:xfrm flipH="1">
                    <a:off x="1118520" y="1670040"/>
                    <a:ext cx="1116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5" name=""/>
                  <p:cNvSpPr/>
                  <p:nvPr/>
                </p:nvSpPr>
                <p:spPr>
                  <a:xfrm flipH="1">
                    <a:off x="1093320" y="1595520"/>
                    <a:ext cx="3636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" name=""/>
                  <p:cNvSpPr/>
                  <p:nvPr/>
                </p:nvSpPr>
                <p:spPr>
                  <a:xfrm flipH="1">
                    <a:off x="1118520" y="1514520"/>
                    <a:ext cx="1116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" name=""/>
                  <p:cNvSpPr/>
                  <p:nvPr/>
                </p:nvSpPr>
                <p:spPr>
                  <a:xfrm flipH="1">
                    <a:off x="1118520" y="1440000"/>
                    <a:ext cx="1116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" name=""/>
                  <p:cNvSpPr/>
                  <p:nvPr/>
                </p:nvSpPr>
                <p:spPr>
                  <a:xfrm flipH="1">
                    <a:off x="1118520" y="1366920"/>
                    <a:ext cx="1116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" name=""/>
                  <p:cNvSpPr/>
                  <p:nvPr/>
                </p:nvSpPr>
                <p:spPr>
                  <a:xfrm flipH="1">
                    <a:off x="1093320" y="1287360"/>
                    <a:ext cx="3636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0" name=""/>
                  <p:cNvSpPr/>
                  <p:nvPr/>
                </p:nvSpPr>
                <p:spPr>
                  <a:xfrm flipH="1">
                    <a:off x="1118520" y="1212840"/>
                    <a:ext cx="1116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1" name=""/>
                  <p:cNvSpPr/>
                  <p:nvPr/>
                </p:nvSpPr>
                <p:spPr>
                  <a:xfrm flipH="1">
                    <a:off x="1118520" y="1138320"/>
                    <a:ext cx="1116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2" name=""/>
                  <p:cNvSpPr/>
                  <p:nvPr/>
                </p:nvSpPr>
                <p:spPr>
                  <a:xfrm flipH="1">
                    <a:off x="1118520" y="1058760"/>
                    <a:ext cx="1116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3" name=""/>
                  <p:cNvSpPr/>
                  <p:nvPr/>
                </p:nvSpPr>
                <p:spPr>
                  <a:xfrm flipH="1">
                    <a:off x="1093320" y="985680"/>
                    <a:ext cx="3636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4" name=""/>
                  <p:cNvSpPr/>
                  <p:nvPr/>
                </p:nvSpPr>
                <p:spPr>
                  <a:xfrm flipH="1">
                    <a:off x="1118520" y="911160"/>
                    <a:ext cx="1116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5" name=""/>
                  <p:cNvSpPr/>
                  <p:nvPr/>
                </p:nvSpPr>
                <p:spPr>
                  <a:xfrm flipH="1">
                    <a:off x="1118520" y="831960"/>
                    <a:ext cx="1116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" name=""/>
                  <p:cNvSpPr/>
                  <p:nvPr/>
                </p:nvSpPr>
                <p:spPr>
                  <a:xfrm flipH="1">
                    <a:off x="1118520" y="757080"/>
                    <a:ext cx="1116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" name=""/>
                  <p:cNvSpPr/>
                  <p:nvPr/>
                </p:nvSpPr>
                <p:spPr>
                  <a:xfrm flipH="1">
                    <a:off x="1093320" y="684360"/>
                    <a:ext cx="3636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28" name=""/>
                <p:cNvSpPr/>
                <p:nvPr/>
              </p:nvSpPr>
              <p:spPr>
                <a:xfrm rot="16200000">
                  <a:off x="707400" y="1329840"/>
                  <a:ext cx="3679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% of Max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29" name=""/>
            <p:cNvSpPr/>
            <p:nvPr/>
          </p:nvSpPr>
          <p:spPr>
            <a:xfrm>
              <a:off x="1143000" y="701640"/>
              <a:ext cx="1565280" cy="1490760"/>
            </a:xfrm>
            <a:custGeom>
              <a:avLst/>
              <a:gdLst/>
              <a:ahLst/>
              <a:rect l="l" t="t" r="r" b="b"/>
              <a:pathLst>
                <a:path w="986" h="939">
                  <a:moveTo>
                    <a:pt x="0" y="939"/>
                  </a:moveTo>
                  <a:lnTo>
                    <a:pt x="0" y="912"/>
                  </a:lnTo>
                  <a:lnTo>
                    <a:pt x="4" y="916"/>
                  </a:lnTo>
                  <a:lnTo>
                    <a:pt x="8" y="920"/>
                  </a:lnTo>
                  <a:lnTo>
                    <a:pt x="12" y="924"/>
                  </a:lnTo>
                  <a:lnTo>
                    <a:pt x="15" y="924"/>
                  </a:lnTo>
                  <a:lnTo>
                    <a:pt x="19" y="927"/>
                  </a:lnTo>
                  <a:lnTo>
                    <a:pt x="24" y="927"/>
                  </a:lnTo>
                  <a:lnTo>
                    <a:pt x="27" y="924"/>
                  </a:lnTo>
                  <a:lnTo>
                    <a:pt x="31" y="924"/>
                  </a:lnTo>
                  <a:lnTo>
                    <a:pt x="35" y="924"/>
                  </a:lnTo>
                  <a:lnTo>
                    <a:pt x="39" y="924"/>
                  </a:lnTo>
                  <a:lnTo>
                    <a:pt x="42" y="924"/>
                  </a:lnTo>
                  <a:lnTo>
                    <a:pt x="47" y="927"/>
                  </a:lnTo>
                  <a:lnTo>
                    <a:pt x="51" y="924"/>
                  </a:lnTo>
                  <a:lnTo>
                    <a:pt x="54" y="924"/>
                  </a:lnTo>
                  <a:lnTo>
                    <a:pt x="58" y="924"/>
                  </a:lnTo>
                  <a:lnTo>
                    <a:pt x="62" y="920"/>
                  </a:lnTo>
                  <a:lnTo>
                    <a:pt x="66" y="916"/>
                  </a:lnTo>
                  <a:lnTo>
                    <a:pt x="70" y="916"/>
                  </a:lnTo>
                  <a:lnTo>
                    <a:pt x="74" y="912"/>
                  </a:lnTo>
                  <a:lnTo>
                    <a:pt x="78" y="912"/>
                  </a:lnTo>
                  <a:lnTo>
                    <a:pt x="81" y="908"/>
                  </a:lnTo>
                  <a:lnTo>
                    <a:pt x="85" y="908"/>
                  </a:lnTo>
                  <a:lnTo>
                    <a:pt x="89" y="908"/>
                  </a:lnTo>
                  <a:lnTo>
                    <a:pt x="94" y="908"/>
                  </a:lnTo>
                  <a:lnTo>
                    <a:pt x="97" y="908"/>
                  </a:lnTo>
                  <a:lnTo>
                    <a:pt x="101" y="912"/>
                  </a:lnTo>
                  <a:lnTo>
                    <a:pt x="105" y="912"/>
                  </a:lnTo>
                  <a:lnTo>
                    <a:pt x="108" y="912"/>
                  </a:lnTo>
                  <a:lnTo>
                    <a:pt x="112" y="912"/>
                  </a:lnTo>
                  <a:lnTo>
                    <a:pt x="117" y="912"/>
                  </a:lnTo>
                  <a:lnTo>
                    <a:pt x="121" y="912"/>
                  </a:lnTo>
                  <a:lnTo>
                    <a:pt x="124" y="912"/>
                  </a:lnTo>
                  <a:lnTo>
                    <a:pt x="128" y="912"/>
                  </a:lnTo>
                  <a:lnTo>
                    <a:pt x="132" y="912"/>
                  </a:lnTo>
                  <a:lnTo>
                    <a:pt x="135" y="912"/>
                  </a:lnTo>
                  <a:lnTo>
                    <a:pt x="140" y="916"/>
                  </a:lnTo>
                  <a:lnTo>
                    <a:pt x="144" y="916"/>
                  </a:lnTo>
                  <a:lnTo>
                    <a:pt x="148" y="920"/>
                  </a:lnTo>
                  <a:lnTo>
                    <a:pt x="151" y="920"/>
                  </a:lnTo>
                  <a:lnTo>
                    <a:pt x="155" y="920"/>
                  </a:lnTo>
                  <a:lnTo>
                    <a:pt x="159" y="916"/>
                  </a:lnTo>
                  <a:lnTo>
                    <a:pt x="163" y="916"/>
                  </a:lnTo>
                  <a:lnTo>
                    <a:pt x="167" y="912"/>
                  </a:lnTo>
                  <a:lnTo>
                    <a:pt x="171" y="908"/>
                  </a:lnTo>
                  <a:lnTo>
                    <a:pt x="175" y="908"/>
                  </a:lnTo>
                  <a:lnTo>
                    <a:pt x="178" y="908"/>
                  </a:lnTo>
                  <a:lnTo>
                    <a:pt x="182" y="908"/>
                  </a:lnTo>
                  <a:lnTo>
                    <a:pt x="187" y="912"/>
                  </a:lnTo>
                  <a:lnTo>
                    <a:pt x="190" y="912"/>
                  </a:lnTo>
                  <a:lnTo>
                    <a:pt x="194" y="916"/>
                  </a:lnTo>
                  <a:lnTo>
                    <a:pt x="198" y="916"/>
                  </a:lnTo>
                  <a:lnTo>
                    <a:pt x="202" y="920"/>
                  </a:lnTo>
                  <a:lnTo>
                    <a:pt x="205" y="924"/>
                  </a:lnTo>
                  <a:lnTo>
                    <a:pt x="210" y="927"/>
                  </a:lnTo>
                  <a:lnTo>
                    <a:pt x="214" y="927"/>
                  </a:lnTo>
                  <a:lnTo>
                    <a:pt x="217" y="931"/>
                  </a:lnTo>
                  <a:lnTo>
                    <a:pt x="221" y="936"/>
                  </a:lnTo>
                  <a:lnTo>
                    <a:pt x="225" y="936"/>
                  </a:lnTo>
                  <a:lnTo>
                    <a:pt x="229" y="936"/>
                  </a:lnTo>
                  <a:lnTo>
                    <a:pt x="233" y="936"/>
                  </a:lnTo>
                  <a:lnTo>
                    <a:pt x="237" y="931"/>
                  </a:lnTo>
                  <a:lnTo>
                    <a:pt x="241" y="927"/>
                  </a:lnTo>
                  <a:lnTo>
                    <a:pt x="244" y="924"/>
                  </a:lnTo>
                  <a:lnTo>
                    <a:pt x="248" y="920"/>
                  </a:lnTo>
                  <a:lnTo>
                    <a:pt x="252" y="916"/>
                  </a:lnTo>
                  <a:lnTo>
                    <a:pt x="256" y="912"/>
                  </a:lnTo>
                  <a:lnTo>
                    <a:pt x="260" y="912"/>
                  </a:lnTo>
                  <a:lnTo>
                    <a:pt x="264" y="912"/>
                  </a:lnTo>
                  <a:lnTo>
                    <a:pt x="268" y="916"/>
                  </a:lnTo>
                  <a:lnTo>
                    <a:pt x="271" y="920"/>
                  </a:lnTo>
                  <a:lnTo>
                    <a:pt x="275" y="924"/>
                  </a:lnTo>
                  <a:lnTo>
                    <a:pt x="280" y="927"/>
                  </a:lnTo>
                  <a:lnTo>
                    <a:pt x="284" y="931"/>
                  </a:lnTo>
                  <a:lnTo>
                    <a:pt x="287" y="931"/>
                  </a:lnTo>
                  <a:lnTo>
                    <a:pt x="291" y="936"/>
                  </a:lnTo>
                  <a:lnTo>
                    <a:pt x="295" y="931"/>
                  </a:lnTo>
                  <a:lnTo>
                    <a:pt x="298" y="931"/>
                  </a:lnTo>
                  <a:lnTo>
                    <a:pt x="303" y="931"/>
                  </a:lnTo>
                  <a:lnTo>
                    <a:pt x="307" y="927"/>
                  </a:lnTo>
                  <a:lnTo>
                    <a:pt x="311" y="927"/>
                  </a:lnTo>
                  <a:lnTo>
                    <a:pt x="314" y="927"/>
                  </a:lnTo>
                  <a:lnTo>
                    <a:pt x="318" y="927"/>
                  </a:lnTo>
                  <a:lnTo>
                    <a:pt x="322" y="927"/>
                  </a:lnTo>
                  <a:lnTo>
                    <a:pt x="326" y="931"/>
                  </a:lnTo>
                  <a:lnTo>
                    <a:pt x="330" y="931"/>
                  </a:lnTo>
                  <a:lnTo>
                    <a:pt x="334" y="936"/>
                  </a:lnTo>
                  <a:lnTo>
                    <a:pt x="338" y="936"/>
                  </a:lnTo>
                  <a:lnTo>
                    <a:pt x="341" y="939"/>
                  </a:lnTo>
                  <a:lnTo>
                    <a:pt x="345" y="939"/>
                  </a:lnTo>
                  <a:lnTo>
                    <a:pt x="350" y="939"/>
                  </a:lnTo>
                  <a:lnTo>
                    <a:pt x="353" y="939"/>
                  </a:lnTo>
                  <a:lnTo>
                    <a:pt x="357" y="939"/>
                  </a:lnTo>
                  <a:lnTo>
                    <a:pt x="361" y="939"/>
                  </a:lnTo>
                  <a:lnTo>
                    <a:pt x="365" y="939"/>
                  </a:lnTo>
                  <a:lnTo>
                    <a:pt x="368" y="939"/>
                  </a:lnTo>
                  <a:lnTo>
                    <a:pt x="373" y="939"/>
                  </a:lnTo>
                  <a:lnTo>
                    <a:pt x="377" y="939"/>
                  </a:lnTo>
                  <a:lnTo>
                    <a:pt x="380" y="939"/>
                  </a:lnTo>
                  <a:lnTo>
                    <a:pt x="384" y="939"/>
                  </a:lnTo>
                  <a:lnTo>
                    <a:pt x="388" y="939"/>
                  </a:lnTo>
                  <a:lnTo>
                    <a:pt x="392" y="939"/>
                  </a:lnTo>
                  <a:lnTo>
                    <a:pt x="396" y="939"/>
                  </a:lnTo>
                  <a:lnTo>
                    <a:pt x="400" y="939"/>
                  </a:lnTo>
                  <a:lnTo>
                    <a:pt x="404" y="939"/>
                  </a:lnTo>
                  <a:lnTo>
                    <a:pt x="407" y="936"/>
                  </a:lnTo>
                  <a:lnTo>
                    <a:pt x="411" y="936"/>
                  </a:lnTo>
                  <a:lnTo>
                    <a:pt x="415" y="931"/>
                  </a:lnTo>
                  <a:lnTo>
                    <a:pt x="419" y="927"/>
                  </a:lnTo>
                  <a:lnTo>
                    <a:pt x="423" y="920"/>
                  </a:lnTo>
                  <a:lnTo>
                    <a:pt x="427" y="916"/>
                  </a:lnTo>
                  <a:lnTo>
                    <a:pt x="431" y="912"/>
                  </a:lnTo>
                  <a:lnTo>
                    <a:pt x="434" y="912"/>
                  </a:lnTo>
                  <a:lnTo>
                    <a:pt x="438" y="912"/>
                  </a:lnTo>
                  <a:lnTo>
                    <a:pt x="443" y="912"/>
                  </a:lnTo>
                  <a:lnTo>
                    <a:pt x="446" y="916"/>
                  </a:lnTo>
                  <a:lnTo>
                    <a:pt x="450" y="916"/>
                  </a:lnTo>
                  <a:lnTo>
                    <a:pt x="454" y="916"/>
                  </a:lnTo>
                  <a:lnTo>
                    <a:pt x="458" y="916"/>
                  </a:lnTo>
                  <a:lnTo>
                    <a:pt x="461" y="916"/>
                  </a:lnTo>
                  <a:lnTo>
                    <a:pt x="466" y="912"/>
                  </a:lnTo>
                  <a:lnTo>
                    <a:pt x="470" y="904"/>
                  </a:lnTo>
                  <a:lnTo>
                    <a:pt x="474" y="900"/>
                  </a:lnTo>
                  <a:lnTo>
                    <a:pt x="477" y="897"/>
                  </a:lnTo>
                  <a:lnTo>
                    <a:pt x="481" y="897"/>
                  </a:lnTo>
                  <a:lnTo>
                    <a:pt x="485" y="897"/>
                  </a:lnTo>
                  <a:lnTo>
                    <a:pt x="489" y="897"/>
                  </a:lnTo>
                  <a:lnTo>
                    <a:pt x="493" y="900"/>
                  </a:lnTo>
                  <a:lnTo>
                    <a:pt x="497" y="908"/>
                  </a:lnTo>
                  <a:lnTo>
                    <a:pt x="501" y="912"/>
                  </a:lnTo>
                  <a:lnTo>
                    <a:pt x="504" y="916"/>
                  </a:lnTo>
                  <a:lnTo>
                    <a:pt x="508" y="916"/>
                  </a:lnTo>
                  <a:lnTo>
                    <a:pt x="513" y="920"/>
                  </a:lnTo>
                  <a:lnTo>
                    <a:pt x="516" y="920"/>
                  </a:lnTo>
                  <a:lnTo>
                    <a:pt x="520" y="920"/>
                  </a:lnTo>
                  <a:lnTo>
                    <a:pt x="524" y="920"/>
                  </a:lnTo>
                  <a:lnTo>
                    <a:pt x="528" y="916"/>
                  </a:lnTo>
                  <a:lnTo>
                    <a:pt x="531" y="916"/>
                  </a:lnTo>
                  <a:lnTo>
                    <a:pt x="536" y="912"/>
                  </a:lnTo>
                  <a:lnTo>
                    <a:pt x="540" y="908"/>
                  </a:lnTo>
                  <a:lnTo>
                    <a:pt x="543" y="904"/>
                  </a:lnTo>
                  <a:lnTo>
                    <a:pt x="547" y="900"/>
                  </a:lnTo>
                  <a:lnTo>
                    <a:pt x="551" y="897"/>
                  </a:lnTo>
                  <a:lnTo>
                    <a:pt x="555" y="897"/>
                  </a:lnTo>
                  <a:lnTo>
                    <a:pt x="559" y="897"/>
                  </a:lnTo>
                  <a:lnTo>
                    <a:pt x="563" y="897"/>
                  </a:lnTo>
                  <a:lnTo>
                    <a:pt x="567" y="897"/>
                  </a:lnTo>
                  <a:lnTo>
                    <a:pt x="570" y="893"/>
                  </a:lnTo>
                  <a:lnTo>
                    <a:pt x="574" y="893"/>
                  </a:lnTo>
                  <a:lnTo>
                    <a:pt x="578" y="889"/>
                  </a:lnTo>
                  <a:lnTo>
                    <a:pt x="582" y="884"/>
                  </a:lnTo>
                  <a:lnTo>
                    <a:pt x="586" y="884"/>
                  </a:lnTo>
                  <a:lnTo>
                    <a:pt x="590" y="881"/>
                  </a:lnTo>
                  <a:lnTo>
                    <a:pt x="594" y="881"/>
                  </a:lnTo>
                  <a:lnTo>
                    <a:pt x="597" y="881"/>
                  </a:lnTo>
                  <a:lnTo>
                    <a:pt x="601" y="884"/>
                  </a:lnTo>
                  <a:lnTo>
                    <a:pt x="606" y="884"/>
                  </a:lnTo>
                  <a:lnTo>
                    <a:pt x="609" y="889"/>
                  </a:lnTo>
                  <a:lnTo>
                    <a:pt x="613" y="884"/>
                  </a:lnTo>
                  <a:lnTo>
                    <a:pt x="617" y="881"/>
                  </a:lnTo>
                  <a:lnTo>
                    <a:pt x="621" y="870"/>
                  </a:lnTo>
                  <a:lnTo>
                    <a:pt x="624" y="861"/>
                  </a:lnTo>
                  <a:lnTo>
                    <a:pt x="629" y="843"/>
                  </a:lnTo>
                  <a:lnTo>
                    <a:pt x="633" y="827"/>
                  </a:lnTo>
                  <a:lnTo>
                    <a:pt x="636" y="807"/>
                  </a:lnTo>
                  <a:lnTo>
                    <a:pt x="640" y="788"/>
                  </a:lnTo>
                  <a:lnTo>
                    <a:pt x="644" y="776"/>
                  </a:lnTo>
                  <a:lnTo>
                    <a:pt x="648" y="768"/>
                  </a:lnTo>
                  <a:lnTo>
                    <a:pt x="652" y="764"/>
                  </a:lnTo>
                  <a:lnTo>
                    <a:pt x="656" y="764"/>
                  </a:lnTo>
                  <a:lnTo>
                    <a:pt x="660" y="768"/>
                  </a:lnTo>
                  <a:lnTo>
                    <a:pt x="663" y="764"/>
                  </a:lnTo>
                  <a:lnTo>
                    <a:pt x="667" y="761"/>
                  </a:lnTo>
                  <a:lnTo>
                    <a:pt x="671" y="749"/>
                  </a:lnTo>
                  <a:lnTo>
                    <a:pt x="676" y="730"/>
                  </a:lnTo>
                  <a:lnTo>
                    <a:pt x="679" y="710"/>
                  </a:lnTo>
                  <a:lnTo>
                    <a:pt x="683" y="687"/>
                  </a:lnTo>
                  <a:lnTo>
                    <a:pt x="687" y="664"/>
                  </a:lnTo>
                  <a:lnTo>
                    <a:pt x="691" y="644"/>
                  </a:lnTo>
                  <a:lnTo>
                    <a:pt x="694" y="628"/>
                  </a:lnTo>
                  <a:lnTo>
                    <a:pt x="699" y="621"/>
                  </a:lnTo>
                  <a:lnTo>
                    <a:pt x="703" y="625"/>
                  </a:lnTo>
                  <a:lnTo>
                    <a:pt x="706" y="640"/>
                  </a:lnTo>
                  <a:lnTo>
                    <a:pt x="710" y="660"/>
                  </a:lnTo>
                  <a:lnTo>
                    <a:pt x="714" y="680"/>
                  </a:lnTo>
                  <a:lnTo>
                    <a:pt x="718" y="675"/>
                  </a:lnTo>
                  <a:lnTo>
                    <a:pt x="722" y="652"/>
                  </a:lnTo>
                  <a:lnTo>
                    <a:pt x="726" y="605"/>
                  </a:lnTo>
                  <a:lnTo>
                    <a:pt x="730" y="547"/>
                  </a:lnTo>
                  <a:lnTo>
                    <a:pt x="733" y="481"/>
                  </a:lnTo>
                  <a:lnTo>
                    <a:pt x="737" y="427"/>
                  </a:lnTo>
                  <a:lnTo>
                    <a:pt x="741" y="377"/>
                  </a:lnTo>
                  <a:lnTo>
                    <a:pt x="745" y="349"/>
                  </a:lnTo>
                  <a:lnTo>
                    <a:pt x="749" y="334"/>
                  </a:lnTo>
                  <a:lnTo>
                    <a:pt x="753" y="326"/>
                  </a:lnTo>
                  <a:lnTo>
                    <a:pt x="757" y="318"/>
                  </a:lnTo>
                  <a:lnTo>
                    <a:pt x="760" y="307"/>
                  </a:lnTo>
                  <a:lnTo>
                    <a:pt x="764" y="295"/>
                  </a:lnTo>
                  <a:lnTo>
                    <a:pt x="769" y="284"/>
                  </a:lnTo>
                  <a:lnTo>
                    <a:pt x="772" y="279"/>
                  </a:lnTo>
                  <a:lnTo>
                    <a:pt x="776" y="272"/>
                  </a:lnTo>
                  <a:lnTo>
                    <a:pt x="780" y="287"/>
                  </a:lnTo>
                  <a:lnTo>
                    <a:pt x="784" y="322"/>
                  </a:lnTo>
                  <a:lnTo>
                    <a:pt x="787" y="361"/>
                  </a:lnTo>
                  <a:lnTo>
                    <a:pt x="792" y="384"/>
                  </a:lnTo>
                  <a:lnTo>
                    <a:pt x="796" y="357"/>
                  </a:lnTo>
                  <a:lnTo>
                    <a:pt x="799" y="284"/>
                  </a:lnTo>
                  <a:lnTo>
                    <a:pt x="803" y="186"/>
                  </a:lnTo>
                  <a:lnTo>
                    <a:pt x="807" y="89"/>
                  </a:lnTo>
                  <a:lnTo>
                    <a:pt x="811" y="19"/>
                  </a:lnTo>
                  <a:lnTo>
                    <a:pt x="815" y="0"/>
                  </a:lnTo>
                  <a:lnTo>
                    <a:pt x="819" y="28"/>
                  </a:lnTo>
                  <a:lnTo>
                    <a:pt x="823" y="89"/>
                  </a:lnTo>
                  <a:lnTo>
                    <a:pt x="826" y="159"/>
                  </a:lnTo>
                  <a:lnTo>
                    <a:pt x="830" y="209"/>
                  </a:lnTo>
                  <a:lnTo>
                    <a:pt x="834" y="237"/>
                  </a:lnTo>
                  <a:lnTo>
                    <a:pt x="839" y="248"/>
                  </a:lnTo>
                  <a:lnTo>
                    <a:pt x="842" y="252"/>
                  </a:lnTo>
                  <a:lnTo>
                    <a:pt x="846" y="260"/>
                  </a:lnTo>
                  <a:lnTo>
                    <a:pt x="850" y="284"/>
                  </a:lnTo>
                  <a:lnTo>
                    <a:pt x="853" y="326"/>
                  </a:lnTo>
                  <a:lnTo>
                    <a:pt x="857" y="381"/>
                  </a:lnTo>
                  <a:lnTo>
                    <a:pt x="862" y="435"/>
                  </a:lnTo>
                  <a:lnTo>
                    <a:pt x="866" y="477"/>
                  </a:lnTo>
                  <a:lnTo>
                    <a:pt x="869" y="508"/>
                  </a:lnTo>
                  <a:lnTo>
                    <a:pt x="873" y="540"/>
                  </a:lnTo>
                  <a:lnTo>
                    <a:pt x="877" y="571"/>
                  </a:lnTo>
                  <a:lnTo>
                    <a:pt x="881" y="590"/>
                  </a:lnTo>
                  <a:lnTo>
                    <a:pt x="885" y="610"/>
                  </a:lnTo>
                  <a:lnTo>
                    <a:pt x="889" y="621"/>
                  </a:lnTo>
                  <a:lnTo>
                    <a:pt x="893" y="633"/>
                  </a:lnTo>
                  <a:lnTo>
                    <a:pt x="896" y="640"/>
                  </a:lnTo>
                  <a:lnTo>
                    <a:pt x="900" y="656"/>
                  </a:lnTo>
                  <a:lnTo>
                    <a:pt x="904" y="671"/>
                  </a:lnTo>
                  <a:lnTo>
                    <a:pt x="908" y="680"/>
                  </a:lnTo>
                  <a:lnTo>
                    <a:pt x="912" y="683"/>
                  </a:lnTo>
                  <a:lnTo>
                    <a:pt x="916" y="680"/>
                  </a:lnTo>
                  <a:lnTo>
                    <a:pt x="920" y="671"/>
                  </a:lnTo>
                  <a:lnTo>
                    <a:pt x="923" y="671"/>
                  </a:lnTo>
                  <a:lnTo>
                    <a:pt x="927" y="680"/>
                  </a:lnTo>
                  <a:lnTo>
                    <a:pt x="932" y="691"/>
                  </a:lnTo>
                  <a:lnTo>
                    <a:pt x="935" y="714"/>
                  </a:lnTo>
                  <a:lnTo>
                    <a:pt x="939" y="741"/>
                  </a:lnTo>
                  <a:lnTo>
                    <a:pt x="943" y="761"/>
                  </a:lnTo>
                  <a:lnTo>
                    <a:pt x="947" y="780"/>
                  </a:lnTo>
                  <a:lnTo>
                    <a:pt x="950" y="784"/>
                  </a:lnTo>
                  <a:lnTo>
                    <a:pt x="955" y="788"/>
                  </a:lnTo>
                  <a:lnTo>
                    <a:pt x="959" y="784"/>
                  </a:lnTo>
                  <a:lnTo>
                    <a:pt x="962" y="784"/>
                  </a:lnTo>
                  <a:lnTo>
                    <a:pt x="966" y="788"/>
                  </a:lnTo>
                  <a:lnTo>
                    <a:pt x="970" y="791"/>
                  </a:lnTo>
                  <a:lnTo>
                    <a:pt x="974" y="803"/>
                  </a:lnTo>
                  <a:lnTo>
                    <a:pt x="978" y="819"/>
                  </a:lnTo>
                  <a:lnTo>
                    <a:pt x="982" y="834"/>
                  </a:lnTo>
                  <a:lnTo>
                    <a:pt x="986" y="843"/>
                  </a:lnTo>
                </a:path>
              </a:pathLst>
            </a:custGeom>
            <a:noFill/>
            <a:ln w="6480">
              <a:solidFill>
                <a:srgbClr val="d6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1143000" y="701640"/>
              <a:ext cx="1565280" cy="1490760"/>
            </a:xfrm>
            <a:custGeom>
              <a:avLst/>
              <a:gdLst/>
              <a:ahLst/>
              <a:rect l="l" t="t" r="r" b="b"/>
              <a:pathLst>
                <a:path w="986" h="939">
                  <a:moveTo>
                    <a:pt x="0" y="939"/>
                  </a:moveTo>
                  <a:lnTo>
                    <a:pt x="0" y="458"/>
                  </a:lnTo>
                  <a:lnTo>
                    <a:pt x="0" y="633"/>
                  </a:lnTo>
                  <a:lnTo>
                    <a:pt x="4" y="807"/>
                  </a:lnTo>
                  <a:lnTo>
                    <a:pt x="8" y="881"/>
                  </a:lnTo>
                  <a:lnTo>
                    <a:pt x="12" y="897"/>
                  </a:lnTo>
                  <a:lnTo>
                    <a:pt x="15" y="893"/>
                  </a:lnTo>
                  <a:lnTo>
                    <a:pt x="19" y="889"/>
                  </a:lnTo>
                  <a:lnTo>
                    <a:pt x="24" y="877"/>
                  </a:lnTo>
                  <a:lnTo>
                    <a:pt x="27" y="873"/>
                  </a:lnTo>
                  <a:lnTo>
                    <a:pt x="31" y="870"/>
                  </a:lnTo>
                  <a:lnTo>
                    <a:pt x="35" y="866"/>
                  </a:lnTo>
                  <a:lnTo>
                    <a:pt x="39" y="870"/>
                  </a:lnTo>
                  <a:lnTo>
                    <a:pt x="42" y="870"/>
                  </a:lnTo>
                  <a:lnTo>
                    <a:pt x="47" y="866"/>
                  </a:lnTo>
                  <a:lnTo>
                    <a:pt x="51" y="857"/>
                  </a:lnTo>
                  <a:lnTo>
                    <a:pt x="54" y="846"/>
                  </a:lnTo>
                  <a:lnTo>
                    <a:pt x="58" y="827"/>
                  </a:lnTo>
                  <a:lnTo>
                    <a:pt x="62" y="796"/>
                  </a:lnTo>
                  <a:lnTo>
                    <a:pt x="66" y="764"/>
                  </a:lnTo>
                  <a:lnTo>
                    <a:pt x="70" y="734"/>
                  </a:lnTo>
                  <a:lnTo>
                    <a:pt x="74" y="707"/>
                  </a:lnTo>
                  <a:lnTo>
                    <a:pt x="78" y="687"/>
                  </a:lnTo>
                  <a:lnTo>
                    <a:pt x="81" y="671"/>
                  </a:lnTo>
                  <a:lnTo>
                    <a:pt x="85" y="660"/>
                  </a:lnTo>
                  <a:lnTo>
                    <a:pt x="89" y="664"/>
                  </a:lnTo>
                  <a:lnTo>
                    <a:pt x="94" y="656"/>
                  </a:lnTo>
                  <a:lnTo>
                    <a:pt x="97" y="625"/>
                  </a:lnTo>
                  <a:lnTo>
                    <a:pt x="101" y="578"/>
                  </a:lnTo>
                  <a:lnTo>
                    <a:pt x="105" y="544"/>
                  </a:lnTo>
                  <a:lnTo>
                    <a:pt x="108" y="524"/>
                  </a:lnTo>
                  <a:lnTo>
                    <a:pt x="112" y="474"/>
                  </a:lnTo>
                  <a:lnTo>
                    <a:pt x="117" y="381"/>
                  </a:lnTo>
                  <a:lnTo>
                    <a:pt x="121" y="307"/>
                  </a:lnTo>
                  <a:lnTo>
                    <a:pt x="124" y="284"/>
                  </a:lnTo>
                  <a:lnTo>
                    <a:pt x="128" y="275"/>
                  </a:lnTo>
                  <a:lnTo>
                    <a:pt x="132" y="256"/>
                  </a:lnTo>
                  <a:lnTo>
                    <a:pt x="135" y="214"/>
                  </a:lnTo>
                  <a:lnTo>
                    <a:pt x="140" y="155"/>
                  </a:lnTo>
                  <a:lnTo>
                    <a:pt x="144" y="109"/>
                  </a:lnTo>
                  <a:lnTo>
                    <a:pt x="148" y="70"/>
                  </a:lnTo>
                  <a:lnTo>
                    <a:pt x="151" y="16"/>
                  </a:lnTo>
                  <a:lnTo>
                    <a:pt x="155" y="0"/>
                  </a:lnTo>
                  <a:lnTo>
                    <a:pt x="159" y="28"/>
                  </a:lnTo>
                  <a:lnTo>
                    <a:pt x="163" y="55"/>
                  </a:lnTo>
                  <a:lnTo>
                    <a:pt x="167" y="43"/>
                  </a:lnTo>
                  <a:lnTo>
                    <a:pt x="171" y="23"/>
                  </a:lnTo>
                  <a:lnTo>
                    <a:pt x="175" y="8"/>
                  </a:lnTo>
                  <a:lnTo>
                    <a:pt x="178" y="4"/>
                  </a:lnTo>
                  <a:lnTo>
                    <a:pt x="182" y="4"/>
                  </a:lnTo>
                  <a:lnTo>
                    <a:pt x="187" y="19"/>
                  </a:lnTo>
                  <a:lnTo>
                    <a:pt x="190" y="51"/>
                  </a:lnTo>
                  <a:lnTo>
                    <a:pt x="194" y="105"/>
                  </a:lnTo>
                  <a:lnTo>
                    <a:pt x="198" y="186"/>
                  </a:lnTo>
                  <a:lnTo>
                    <a:pt x="202" y="264"/>
                  </a:lnTo>
                  <a:lnTo>
                    <a:pt x="205" y="287"/>
                  </a:lnTo>
                  <a:lnTo>
                    <a:pt x="210" y="287"/>
                  </a:lnTo>
                  <a:lnTo>
                    <a:pt x="214" y="318"/>
                  </a:lnTo>
                  <a:lnTo>
                    <a:pt x="217" y="372"/>
                  </a:lnTo>
                  <a:lnTo>
                    <a:pt x="221" y="404"/>
                  </a:lnTo>
                  <a:lnTo>
                    <a:pt x="225" y="431"/>
                  </a:lnTo>
                  <a:lnTo>
                    <a:pt x="229" y="477"/>
                  </a:lnTo>
                  <a:lnTo>
                    <a:pt x="233" y="531"/>
                  </a:lnTo>
                  <a:lnTo>
                    <a:pt x="237" y="574"/>
                  </a:lnTo>
                  <a:lnTo>
                    <a:pt x="241" y="605"/>
                  </a:lnTo>
                  <a:lnTo>
                    <a:pt x="244" y="637"/>
                  </a:lnTo>
                  <a:lnTo>
                    <a:pt x="248" y="667"/>
                  </a:lnTo>
                  <a:lnTo>
                    <a:pt x="252" y="694"/>
                  </a:lnTo>
                  <a:lnTo>
                    <a:pt x="256" y="707"/>
                  </a:lnTo>
                  <a:lnTo>
                    <a:pt x="260" y="714"/>
                  </a:lnTo>
                  <a:lnTo>
                    <a:pt x="264" y="718"/>
                  </a:lnTo>
                  <a:lnTo>
                    <a:pt x="268" y="718"/>
                  </a:lnTo>
                  <a:lnTo>
                    <a:pt x="271" y="721"/>
                  </a:lnTo>
                  <a:lnTo>
                    <a:pt x="275" y="718"/>
                  </a:lnTo>
                  <a:lnTo>
                    <a:pt x="280" y="714"/>
                  </a:lnTo>
                  <a:lnTo>
                    <a:pt x="284" y="707"/>
                  </a:lnTo>
                  <a:lnTo>
                    <a:pt x="287" y="698"/>
                  </a:lnTo>
                  <a:lnTo>
                    <a:pt x="291" y="694"/>
                  </a:lnTo>
                  <a:lnTo>
                    <a:pt x="295" y="680"/>
                  </a:lnTo>
                  <a:lnTo>
                    <a:pt x="298" y="664"/>
                  </a:lnTo>
                  <a:lnTo>
                    <a:pt x="303" y="656"/>
                  </a:lnTo>
                  <a:lnTo>
                    <a:pt x="307" y="664"/>
                  </a:lnTo>
                  <a:lnTo>
                    <a:pt x="311" y="680"/>
                  </a:lnTo>
                  <a:lnTo>
                    <a:pt x="314" y="698"/>
                  </a:lnTo>
                  <a:lnTo>
                    <a:pt x="318" y="707"/>
                  </a:lnTo>
                  <a:lnTo>
                    <a:pt x="322" y="698"/>
                  </a:lnTo>
                  <a:lnTo>
                    <a:pt x="326" y="675"/>
                  </a:lnTo>
                  <a:lnTo>
                    <a:pt x="330" y="652"/>
                  </a:lnTo>
                  <a:lnTo>
                    <a:pt x="334" y="625"/>
                  </a:lnTo>
                  <a:lnTo>
                    <a:pt x="338" y="610"/>
                  </a:lnTo>
                  <a:lnTo>
                    <a:pt x="341" y="617"/>
                  </a:lnTo>
                  <a:lnTo>
                    <a:pt x="345" y="644"/>
                  </a:lnTo>
                  <a:lnTo>
                    <a:pt x="350" y="660"/>
                  </a:lnTo>
                  <a:lnTo>
                    <a:pt x="353" y="652"/>
                  </a:lnTo>
                  <a:lnTo>
                    <a:pt x="357" y="637"/>
                  </a:lnTo>
                  <a:lnTo>
                    <a:pt x="361" y="625"/>
                  </a:lnTo>
                  <a:lnTo>
                    <a:pt x="365" y="617"/>
                  </a:lnTo>
                  <a:lnTo>
                    <a:pt x="368" y="601"/>
                  </a:lnTo>
                  <a:lnTo>
                    <a:pt x="373" y="586"/>
                  </a:lnTo>
                  <a:lnTo>
                    <a:pt x="377" y="578"/>
                  </a:lnTo>
                  <a:lnTo>
                    <a:pt x="380" y="590"/>
                  </a:lnTo>
                  <a:lnTo>
                    <a:pt x="384" y="617"/>
                  </a:lnTo>
                  <a:lnTo>
                    <a:pt x="388" y="648"/>
                  </a:lnTo>
                  <a:lnTo>
                    <a:pt x="392" y="667"/>
                  </a:lnTo>
                  <a:lnTo>
                    <a:pt x="396" y="664"/>
                  </a:lnTo>
                  <a:lnTo>
                    <a:pt x="400" y="648"/>
                  </a:lnTo>
                  <a:lnTo>
                    <a:pt x="404" y="633"/>
                  </a:lnTo>
                  <a:lnTo>
                    <a:pt x="407" y="640"/>
                  </a:lnTo>
                  <a:lnTo>
                    <a:pt x="411" y="656"/>
                  </a:lnTo>
                  <a:lnTo>
                    <a:pt x="415" y="664"/>
                  </a:lnTo>
                  <a:lnTo>
                    <a:pt x="419" y="671"/>
                  </a:lnTo>
                  <a:lnTo>
                    <a:pt x="423" y="671"/>
                  </a:lnTo>
                  <a:lnTo>
                    <a:pt x="427" y="667"/>
                  </a:lnTo>
                  <a:lnTo>
                    <a:pt x="431" y="656"/>
                  </a:lnTo>
                  <a:lnTo>
                    <a:pt x="434" y="648"/>
                  </a:lnTo>
                  <a:lnTo>
                    <a:pt x="438" y="644"/>
                  </a:lnTo>
                  <a:lnTo>
                    <a:pt x="443" y="640"/>
                  </a:lnTo>
                  <a:lnTo>
                    <a:pt x="446" y="628"/>
                  </a:lnTo>
                  <a:lnTo>
                    <a:pt x="450" y="617"/>
                  </a:lnTo>
                  <a:lnTo>
                    <a:pt x="454" y="605"/>
                  </a:lnTo>
                  <a:lnTo>
                    <a:pt x="458" y="598"/>
                  </a:lnTo>
                  <a:lnTo>
                    <a:pt x="461" y="590"/>
                  </a:lnTo>
                  <a:lnTo>
                    <a:pt x="466" y="586"/>
                  </a:lnTo>
                  <a:lnTo>
                    <a:pt x="470" y="605"/>
                  </a:lnTo>
                  <a:lnTo>
                    <a:pt x="474" y="633"/>
                  </a:lnTo>
                  <a:lnTo>
                    <a:pt x="477" y="648"/>
                  </a:lnTo>
                  <a:lnTo>
                    <a:pt x="481" y="652"/>
                  </a:lnTo>
                  <a:lnTo>
                    <a:pt x="485" y="664"/>
                  </a:lnTo>
                  <a:lnTo>
                    <a:pt x="489" y="680"/>
                  </a:lnTo>
                  <a:lnTo>
                    <a:pt x="493" y="683"/>
                  </a:lnTo>
                  <a:lnTo>
                    <a:pt x="497" y="675"/>
                  </a:lnTo>
                  <a:lnTo>
                    <a:pt x="501" y="675"/>
                  </a:lnTo>
                  <a:lnTo>
                    <a:pt x="504" y="687"/>
                  </a:lnTo>
                  <a:lnTo>
                    <a:pt x="508" y="707"/>
                  </a:lnTo>
                  <a:lnTo>
                    <a:pt x="513" y="726"/>
                  </a:lnTo>
                  <a:lnTo>
                    <a:pt x="516" y="734"/>
                  </a:lnTo>
                  <a:lnTo>
                    <a:pt x="520" y="734"/>
                  </a:lnTo>
                  <a:lnTo>
                    <a:pt x="524" y="737"/>
                  </a:lnTo>
                  <a:lnTo>
                    <a:pt x="528" y="745"/>
                  </a:lnTo>
                  <a:lnTo>
                    <a:pt x="531" y="749"/>
                  </a:lnTo>
                  <a:lnTo>
                    <a:pt x="536" y="741"/>
                  </a:lnTo>
                  <a:lnTo>
                    <a:pt x="540" y="730"/>
                  </a:lnTo>
                  <a:lnTo>
                    <a:pt x="543" y="726"/>
                  </a:lnTo>
                  <a:lnTo>
                    <a:pt x="547" y="734"/>
                  </a:lnTo>
                  <a:lnTo>
                    <a:pt x="551" y="745"/>
                  </a:lnTo>
                  <a:lnTo>
                    <a:pt x="555" y="757"/>
                  </a:lnTo>
                  <a:lnTo>
                    <a:pt x="559" y="764"/>
                  </a:lnTo>
                  <a:lnTo>
                    <a:pt x="563" y="780"/>
                  </a:lnTo>
                  <a:lnTo>
                    <a:pt x="567" y="796"/>
                  </a:lnTo>
                  <a:lnTo>
                    <a:pt x="570" y="815"/>
                  </a:lnTo>
                  <a:lnTo>
                    <a:pt x="574" y="827"/>
                  </a:lnTo>
                  <a:lnTo>
                    <a:pt x="578" y="830"/>
                  </a:lnTo>
                  <a:lnTo>
                    <a:pt x="582" y="830"/>
                  </a:lnTo>
                  <a:lnTo>
                    <a:pt x="586" y="827"/>
                  </a:lnTo>
                  <a:lnTo>
                    <a:pt x="590" y="819"/>
                  </a:lnTo>
                  <a:lnTo>
                    <a:pt x="594" y="819"/>
                  </a:lnTo>
                  <a:lnTo>
                    <a:pt x="597" y="823"/>
                  </a:lnTo>
                  <a:lnTo>
                    <a:pt x="601" y="830"/>
                  </a:lnTo>
                  <a:lnTo>
                    <a:pt x="606" y="838"/>
                  </a:lnTo>
                  <a:lnTo>
                    <a:pt x="609" y="843"/>
                  </a:lnTo>
                  <a:lnTo>
                    <a:pt x="613" y="843"/>
                  </a:lnTo>
                  <a:lnTo>
                    <a:pt x="617" y="838"/>
                  </a:lnTo>
                  <a:lnTo>
                    <a:pt x="621" y="834"/>
                  </a:lnTo>
                  <a:lnTo>
                    <a:pt x="624" y="823"/>
                  </a:lnTo>
                  <a:lnTo>
                    <a:pt x="629" y="815"/>
                  </a:lnTo>
                  <a:lnTo>
                    <a:pt x="633" y="811"/>
                  </a:lnTo>
                  <a:lnTo>
                    <a:pt x="636" y="819"/>
                  </a:lnTo>
                  <a:lnTo>
                    <a:pt x="640" y="838"/>
                  </a:lnTo>
                  <a:lnTo>
                    <a:pt x="644" y="854"/>
                  </a:lnTo>
                  <a:lnTo>
                    <a:pt x="648" y="870"/>
                  </a:lnTo>
                  <a:lnTo>
                    <a:pt x="652" y="873"/>
                  </a:lnTo>
                  <a:lnTo>
                    <a:pt x="656" y="877"/>
                  </a:lnTo>
                  <a:lnTo>
                    <a:pt x="660" y="873"/>
                  </a:lnTo>
                  <a:lnTo>
                    <a:pt x="663" y="870"/>
                  </a:lnTo>
                  <a:lnTo>
                    <a:pt x="667" y="870"/>
                  </a:lnTo>
                  <a:lnTo>
                    <a:pt x="671" y="866"/>
                  </a:lnTo>
                  <a:lnTo>
                    <a:pt x="676" y="866"/>
                  </a:lnTo>
                  <a:lnTo>
                    <a:pt x="679" y="861"/>
                  </a:lnTo>
                  <a:lnTo>
                    <a:pt x="683" y="857"/>
                  </a:lnTo>
                  <a:lnTo>
                    <a:pt x="687" y="857"/>
                  </a:lnTo>
                  <a:lnTo>
                    <a:pt x="691" y="861"/>
                  </a:lnTo>
                  <a:lnTo>
                    <a:pt x="694" y="870"/>
                  </a:lnTo>
                  <a:lnTo>
                    <a:pt x="699" y="873"/>
                  </a:lnTo>
                  <a:lnTo>
                    <a:pt x="703" y="881"/>
                  </a:lnTo>
                  <a:lnTo>
                    <a:pt x="706" y="884"/>
                  </a:lnTo>
                  <a:lnTo>
                    <a:pt x="710" y="893"/>
                  </a:lnTo>
                  <a:lnTo>
                    <a:pt x="714" y="897"/>
                  </a:lnTo>
                  <a:lnTo>
                    <a:pt x="718" y="900"/>
                  </a:lnTo>
                  <a:lnTo>
                    <a:pt x="722" y="904"/>
                  </a:lnTo>
                  <a:lnTo>
                    <a:pt x="726" y="904"/>
                  </a:lnTo>
                  <a:lnTo>
                    <a:pt x="730" y="904"/>
                  </a:lnTo>
                  <a:lnTo>
                    <a:pt x="733" y="904"/>
                  </a:lnTo>
                  <a:lnTo>
                    <a:pt x="737" y="904"/>
                  </a:lnTo>
                  <a:lnTo>
                    <a:pt x="741" y="900"/>
                  </a:lnTo>
                  <a:lnTo>
                    <a:pt x="745" y="900"/>
                  </a:lnTo>
                  <a:lnTo>
                    <a:pt x="749" y="900"/>
                  </a:lnTo>
                  <a:lnTo>
                    <a:pt x="753" y="904"/>
                  </a:lnTo>
                  <a:lnTo>
                    <a:pt x="757" y="908"/>
                  </a:lnTo>
                  <a:lnTo>
                    <a:pt x="760" y="908"/>
                  </a:lnTo>
                  <a:lnTo>
                    <a:pt x="764" y="912"/>
                  </a:lnTo>
                  <a:lnTo>
                    <a:pt x="769" y="908"/>
                  </a:lnTo>
                  <a:lnTo>
                    <a:pt x="772" y="904"/>
                  </a:lnTo>
                  <a:lnTo>
                    <a:pt x="776" y="900"/>
                  </a:lnTo>
                  <a:lnTo>
                    <a:pt x="780" y="900"/>
                  </a:lnTo>
                  <a:lnTo>
                    <a:pt x="784" y="900"/>
                  </a:lnTo>
                  <a:lnTo>
                    <a:pt x="787" y="904"/>
                  </a:lnTo>
                  <a:lnTo>
                    <a:pt x="792" y="912"/>
                  </a:lnTo>
                  <a:lnTo>
                    <a:pt x="796" y="916"/>
                  </a:lnTo>
                  <a:lnTo>
                    <a:pt x="799" y="920"/>
                  </a:lnTo>
                  <a:lnTo>
                    <a:pt x="803" y="924"/>
                  </a:lnTo>
                  <a:lnTo>
                    <a:pt x="807" y="924"/>
                  </a:lnTo>
                  <a:lnTo>
                    <a:pt x="811" y="927"/>
                  </a:lnTo>
                  <a:lnTo>
                    <a:pt x="815" y="927"/>
                  </a:lnTo>
                  <a:lnTo>
                    <a:pt x="819" y="931"/>
                  </a:lnTo>
                  <a:lnTo>
                    <a:pt x="823" y="931"/>
                  </a:lnTo>
                  <a:lnTo>
                    <a:pt x="826" y="931"/>
                  </a:lnTo>
                  <a:lnTo>
                    <a:pt x="830" y="931"/>
                  </a:lnTo>
                  <a:lnTo>
                    <a:pt x="834" y="931"/>
                  </a:lnTo>
                  <a:lnTo>
                    <a:pt x="839" y="936"/>
                  </a:lnTo>
                  <a:lnTo>
                    <a:pt x="842" y="936"/>
                  </a:lnTo>
                  <a:lnTo>
                    <a:pt x="846" y="936"/>
                  </a:lnTo>
                  <a:lnTo>
                    <a:pt x="850" y="936"/>
                  </a:lnTo>
                  <a:lnTo>
                    <a:pt x="853" y="939"/>
                  </a:lnTo>
                  <a:lnTo>
                    <a:pt x="857" y="939"/>
                  </a:lnTo>
                  <a:lnTo>
                    <a:pt x="862" y="939"/>
                  </a:lnTo>
                  <a:lnTo>
                    <a:pt x="866" y="939"/>
                  </a:lnTo>
                  <a:lnTo>
                    <a:pt x="869" y="939"/>
                  </a:lnTo>
                  <a:lnTo>
                    <a:pt x="873" y="939"/>
                  </a:lnTo>
                  <a:lnTo>
                    <a:pt x="877" y="939"/>
                  </a:lnTo>
                  <a:lnTo>
                    <a:pt x="881" y="939"/>
                  </a:lnTo>
                  <a:lnTo>
                    <a:pt x="885" y="939"/>
                  </a:lnTo>
                  <a:lnTo>
                    <a:pt x="889" y="939"/>
                  </a:lnTo>
                  <a:lnTo>
                    <a:pt x="893" y="939"/>
                  </a:lnTo>
                  <a:lnTo>
                    <a:pt x="896" y="939"/>
                  </a:lnTo>
                  <a:lnTo>
                    <a:pt x="900" y="939"/>
                  </a:lnTo>
                  <a:lnTo>
                    <a:pt x="904" y="939"/>
                  </a:lnTo>
                  <a:lnTo>
                    <a:pt x="908" y="939"/>
                  </a:lnTo>
                  <a:lnTo>
                    <a:pt x="912" y="939"/>
                  </a:lnTo>
                  <a:lnTo>
                    <a:pt x="916" y="939"/>
                  </a:lnTo>
                  <a:lnTo>
                    <a:pt x="920" y="939"/>
                  </a:lnTo>
                  <a:lnTo>
                    <a:pt x="923" y="939"/>
                  </a:lnTo>
                  <a:lnTo>
                    <a:pt x="927" y="936"/>
                  </a:lnTo>
                  <a:lnTo>
                    <a:pt x="932" y="936"/>
                  </a:lnTo>
                  <a:lnTo>
                    <a:pt x="935" y="936"/>
                  </a:lnTo>
                  <a:lnTo>
                    <a:pt x="939" y="936"/>
                  </a:lnTo>
                  <a:lnTo>
                    <a:pt x="943" y="939"/>
                  </a:lnTo>
                  <a:lnTo>
                    <a:pt x="947" y="939"/>
                  </a:lnTo>
                  <a:lnTo>
                    <a:pt x="950" y="939"/>
                  </a:lnTo>
                  <a:lnTo>
                    <a:pt x="955" y="939"/>
                  </a:lnTo>
                  <a:lnTo>
                    <a:pt x="959" y="939"/>
                  </a:lnTo>
                  <a:lnTo>
                    <a:pt x="962" y="939"/>
                  </a:lnTo>
                  <a:lnTo>
                    <a:pt x="966" y="939"/>
                  </a:lnTo>
                  <a:lnTo>
                    <a:pt x="970" y="936"/>
                  </a:lnTo>
                  <a:lnTo>
                    <a:pt x="974" y="936"/>
                  </a:lnTo>
                  <a:lnTo>
                    <a:pt x="978" y="931"/>
                  </a:lnTo>
                  <a:lnTo>
                    <a:pt x="982" y="927"/>
                  </a:lnTo>
                  <a:lnTo>
                    <a:pt x="986" y="924"/>
                  </a:lnTo>
                </a:path>
              </a:pathLst>
            </a:custGeom>
            <a:noFill/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1" name=""/>
          <p:cNvSpPr/>
          <p:nvPr/>
        </p:nvSpPr>
        <p:spPr>
          <a:xfrm>
            <a:off x="0" y="6583320"/>
            <a:ext cx="457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dditional Data File 5. Meyer et 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6-18T20:14:22Z</dcterms:created>
  <dc:creator>Matthew Meyer</dc:creator>
  <dc:description/>
  <dc:language>en-US</dc:language>
  <cp:lastModifiedBy>Matt Meyer</cp:lastModifiedBy>
  <cp:lastPrinted>2009-10-21T13:31:49Z</cp:lastPrinted>
  <dcterms:modified xsi:type="dcterms:W3CDTF">2009-11-06T21:43:27Z</dcterms:modified>
  <cp:revision>338</cp:revision>
  <dc:subject/>
  <dc:title>PowerPoint Presentation</dc:title>
</cp:coreProperties>
</file>